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90FC0C-3B1A-4795-A6A4-74D21B66FF8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752B83-9315-4D39-BAC1-91C26175DA2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4F6763-37D9-4E48-B66D-9593FB4EF25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6270E7-E390-47EF-9A5E-B36624EDE55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07E0DC-CF31-4BD0-B268-98CA3D3D292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25F7C2-8C18-49F4-927E-FB0A384EDED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47C031-A09B-4168-862B-194BD81C292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FA09CC-84A9-4D18-9BD9-CCA915CA87C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2634FF-2E4F-42A0-8BAB-A75ACDEEB16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771AC5-FF14-4845-BF99-C36EAA309C9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1307E2-A3DD-42EA-A076-347ADE45019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B11E6C-C848-486B-9DB5-FEA876C10A5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306407A-F798-4E57-8C47-2FFB218E9D0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52280" y="1066680"/>
          <a:ext cx="8834400" cy="3657600"/>
        </p:xfrm>
        <a:graphic>
          <a:graphicData uri="http://schemas.openxmlformats.org/drawingml/2006/table">
            <a:tbl>
              <a:tblPr/>
              <a:tblGrid>
                <a:gridCol w="588960"/>
                <a:gridCol w="588960"/>
                <a:gridCol w="588960"/>
                <a:gridCol w="588960"/>
                <a:gridCol w="588960"/>
                <a:gridCol w="588960"/>
                <a:gridCol w="588960"/>
                <a:gridCol w="588960"/>
                <a:gridCol w="588960"/>
                <a:gridCol w="588960"/>
                <a:gridCol w="588960"/>
                <a:gridCol w="588960"/>
                <a:gridCol w="588960"/>
                <a:gridCol w="588960"/>
                <a:gridCol w="588960"/>
              </a:tblGrid>
              <a:tr h="20484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A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UCAN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PAF-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SP-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RD-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CL-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AIDD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OP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OL-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LAN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ICK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CEBER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RD-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S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4948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.D.*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cc00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A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</a:tr>
              <a:tr h="24732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UCAN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</a:tr>
              <a:tr h="24948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ffffff"/>
                          </a:solidFill>
                          <a:latin typeface="Arial"/>
                          <a:ea typeface="Arial"/>
                        </a:rPr>
                        <a:t>shif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a89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PAF-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</a:tr>
              <a:tr h="24768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SP-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</a:tr>
              <a:tr h="28872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.D.*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cc00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RD-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</a:tr>
              <a:tr h="24768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.D.*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cc00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CL-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</a:tr>
              <a:tr h="24912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AIDD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</a:tr>
              <a:tr h="24948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OP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</a:tr>
              <a:tr h="24912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OL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</a:tr>
              <a:tr h="24768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LAN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</a:tr>
              <a:tr h="22068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ICK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</a:tr>
              <a:tr h="24444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CEBER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</a:tr>
              <a:tr h="23976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RD-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</a:tr>
              <a:tr h="22212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S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99ff33"/>
                    </a:solidFill>
                  </a:tcPr>
                </a:tc>
              </a:tr>
            </a:tbl>
          </a:graphicData>
        </a:graphic>
      </p:graphicFrame>
      <p:sp>
        <p:nvSpPr>
          <p:cNvPr id="42" name=""/>
          <p:cNvSpPr/>
          <p:nvPr/>
        </p:nvSpPr>
        <p:spPr>
          <a:xfrm>
            <a:off x="380880" y="4876920"/>
            <a:ext cx="5410440" cy="214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533520" y="5105520"/>
            <a:ext cx="228600" cy="152280"/>
          </a:xfrm>
          <a:prstGeom prst="rect">
            <a:avLst/>
          </a:prstGeom>
          <a:solidFill>
            <a:srgbClr val="99cc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965880" y="4952880"/>
            <a:ext cx="7399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Intensity decrease by comassie blue staining of the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inding partners but no protein complex were detec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533520" y="5562720"/>
            <a:ext cx="228600" cy="152280"/>
          </a:xfrm>
          <a:prstGeom prst="rect">
            <a:avLst/>
          </a:prstGeom>
          <a:solidFill>
            <a:srgbClr val="ffa89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978840" y="5497560"/>
            <a:ext cx="360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hifted band corresponding to the protein complex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533520" y="6019920"/>
            <a:ext cx="228600" cy="15228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986040" y="5973840"/>
            <a:ext cx="1626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o binding observed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2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4-09-24T16:46:53Z</dcterms:created>
  <dc:creator>Houston</dc:creator>
  <dc:description/>
  <dc:language>en-US</dc:language>
  <cp:lastModifiedBy>F PIO</cp:lastModifiedBy>
  <dcterms:modified xsi:type="dcterms:W3CDTF">2005-05-16T20:32:17Z</dcterms:modified>
  <cp:revision>20</cp:revision>
  <dc:subject/>
  <dc:title>Slide 1</dc:title>
</cp:coreProperties>
</file>